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792913" cy="99329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D99193B-F49F-415A-A4BE-D6CCC31B531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1E93FC9-3B24-452A-8BD9-9508E6F95CD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9F577C1-8A6E-4339-AB3D-55873017C2F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8C45B93-8E0D-4A97-8FDF-258C4E08A17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A5327B6-6661-4712-95A5-0050AA9AA2E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34E0683-66EC-41AB-B8FE-EAC8BBB2D8A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9FBB103-02A1-4811-AF23-14A862F6EB1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42DFCE1-EF31-47C5-A380-2CF254F166D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DB6E94B-2B58-41CB-8CD9-D673831FEC4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0C0F091-1026-4DD4-B922-8F94662FEC2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5B9CFCE-0000-4B12-A40A-DEEDC9965F6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8596467-7BA8-464F-9EE3-FD7992F0E52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2AE0C91-6AB2-43A6-82F2-8C8C331DCC15}" type="datetime">
              <a:rPr b="0" lang="ja-JP" sz="1200" spc="-1" strike="noStrike">
                <a:solidFill>
                  <a:srgbClr val="898989"/>
                </a:solidFill>
                <a:latin typeface="Calibri"/>
              </a:rPr>
              <a:t>26/08/29</a:t>
            </a:fld>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7A05569-3DB9-44EF-A42F-B6F9F81871E6}"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テキスト ボックス 3"/>
          <p:cNvSpPr/>
          <p:nvPr/>
        </p:nvSpPr>
        <p:spPr>
          <a:xfrm>
            <a:off x="152280" y="382680"/>
            <a:ext cx="302436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upplementary Figure S3</a:t>
            </a:r>
            <a:endParaRPr b="0" lang="en-US" sz="1600" spc="-1" strike="noStrike">
              <a:solidFill>
                <a:srgbClr val="000000"/>
              </a:solidFill>
              <a:latin typeface="Arial"/>
            </a:endParaRPr>
          </a:p>
        </p:txBody>
      </p:sp>
      <p:sp>
        <p:nvSpPr>
          <p:cNvPr id="42" name="テキスト ボックス 1"/>
          <p:cNvSpPr/>
          <p:nvPr/>
        </p:nvSpPr>
        <p:spPr>
          <a:xfrm>
            <a:off x="333360" y="5624640"/>
            <a:ext cx="6120000" cy="1189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Supplementary Figure S3. Dose response of rVpr induced L1-RTP in HEK293T cells. HEK293T cells were transfected with pEF06R and selected with puromycin. Replated cells were treated with indicated amounts of rVpr for 2days, and then gDNA samples were extracted. Quantities of  </a:t>
            </a:r>
            <a:r>
              <a:rPr b="1" i="1" lang="en-US" sz="1200" spc="-1" strike="noStrike">
                <a:solidFill>
                  <a:srgbClr val="000000"/>
                </a:solidFill>
                <a:latin typeface="Arial"/>
                <a:ea typeface="Times New Roman"/>
              </a:rPr>
              <a:t>EGFP</a:t>
            </a:r>
            <a:r>
              <a:rPr b="1" lang="en-US" sz="1200" spc="-1" strike="noStrike">
                <a:solidFill>
                  <a:srgbClr val="000000"/>
                </a:solidFill>
                <a:latin typeface="Arial"/>
                <a:ea typeface="Times New Roman"/>
              </a:rPr>
              <a:t>  genes which results from L1-RTP were analyzed by qPCR, and normalized by internal control gene (β</a:t>
            </a:r>
            <a:r>
              <a:rPr b="1" i="1" lang="en-US" sz="1200" spc="-1" strike="noStrike">
                <a:solidFill>
                  <a:srgbClr val="000000"/>
                </a:solidFill>
                <a:latin typeface="Arial"/>
                <a:ea typeface="Times New Roman"/>
              </a:rPr>
              <a:t>-globin</a:t>
            </a:r>
            <a:r>
              <a:rPr b="1" lang="en-US" sz="1200" spc="-1" strike="noStrike">
                <a:solidFill>
                  <a:srgbClr val="000000"/>
                </a:solidFill>
                <a:latin typeface="Arial"/>
                <a:ea typeface="Times New Roman"/>
              </a:rPr>
              <a:t>) . A representative data was indicated.</a:t>
            </a:r>
            <a:endParaRPr b="0" lang="en-US" sz="1200" spc="-1" strike="noStrike">
              <a:solidFill>
                <a:srgbClr val="000000"/>
              </a:solidFill>
              <a:latin typeface="Arial"/>
            </a:endParaRPr>
          </a:p>
        </p:txBody>
      </p:sp>
      <p:pic>
        <p:nvPicPr>
          <p:cNvPr id="43" name="Picture 2" descr=""/>
          <p:cNvPicPr/>
          <p:nvPr/>
        </p:nvPicPr>
        <p:blipFill>
          <a:blip r:embed="rId1"/>
          <a:stretch/>
        </p:blipFill>
        <p:spPr>
          <a:xfrm>
            <a:off x="620640" y="920880"/>
            <a:ext cx="5546880" cy="42480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70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6-12T00:59:02Z</dcterms:created>
  <dc:creator>奥平准之</dc:creator>
  <dc:description/>
  <dc:language>en-US</dc:language>
  <cp:lastModifiedBy>Santos, Noribeth</cp:lastModifiedBy>
  <cp:lastPrinted>2013-06-12T04:06:08Z</cp:lastPrinted>
  <dcterms:modified xsi:type="dcterms:W3CDTF">2013-06-14T07:45:52Z</dcterms:modified>
  <cp:revision>1632</cp:revision>
  <dc:subject/>
  <dc:title>スライド 1</dc:title>
</cp:coreProperties>
</file>